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37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BE71E-4C1D-4CE0-9AAA-C6608A10E457}" type="datetimeFigureOut">
              <a:rPr lang="en-GB" smtClean="0"/>
              <a:t>14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E2B16-9ECF-4133-95EC-7B4026D81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53405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BE71E-4C1D-4CE0-9AAA-C6608A10E457}" type="datetimeFigureOut">
              <a:rPr lang="en-GB" smtClean="0"/>
              <a:t>14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E2B16-9ECF-4133-95EC-7B4026D81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7240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BE71E-4C1D-4CE0-9AAA-C6608A10E457}" type="datetimeFigureOut">
              <a:rPr lang="en-GB" smtClean="0"/>
              <a:t>14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E2B16-9ECF-4133-95EC-7B4026D81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4876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BE71E-4C1D-4CE0-9AAA-C6608A10E457}" type="datetimeFigureOut">
              <a:rPr lang="en-GB" smtClean="0"/>
              <a:t>14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E2B16-9ECF-4133-95EC-7B4026D81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9693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BE71E-4C1D-4CE0-9AAA-C6608A10E457}" type="datetimeFigureOut">
              <a:rPr lang="en-GB" smtClean="0"/>
              <a:t>14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E2B16-9ECF-4133-95EC-7B4026D81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28289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BE71E-4C1D-4CE0-9AAA-C6608A10E457}" type="datetimeFigureOut">
              <a:rPr lang="en-GB" smtClean="0"/>
              <a:t>14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E2B16-9ECF-4133-95EC-7B4026D81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0257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BE71E-4C1D-4CE0-9AAA-C6608A10E457}" type="datetimeFigureOut">
              <a:rPr lang="en-GB" smtClean="0"/>
              <a:t>14/03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E2B16-9ECF-4133-95EC-7B4026D81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0865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BE71E-4C1D-4CE0-9AAA-C6608A10E457}" type="datetimeFigureOut">
              <a:rPr lang="en-GB" smtClean="0"/>
              <a:t>14/03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E2B16-9ECF-4133-95EC-7B4026D81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26137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BE71E-4C1D-4CE0-9AAA-C6608A10E457}" type="datetimeFigureOut">
              <a:rPr lang="en-GB" smtClean="0"/>
              <a:t>14/03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E2B16-9ECF-4133-95EC-7B4026D81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5840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BE71E-4C1D-4CE0-9AAA-C6608A10E457}" type="datetimeFigureOut">
              <a:rPr lang="en-GB" smtClean="0"/>
              <a:t>14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E2B16-9ECF-4133-95EC-7B4026D81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90042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BE71E-4C1D-4CE0-9AAA-C6608A10E457}" type="datetimeFigureOut">
              <a:rPr lang="en-GB" smtClean="0"/>
              <a:t>14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E2B16-9ECF-4133-95EC-7B4026D81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64990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EBE71E-4C1D-4CE0-9AAA-C6608A10E457}" type="datetimeFigureOut">
              <a:rPr lang="en-GB" smtClean="0"/>
              <a:t>14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E2B16-9ECF-4133-95EC-7B4026D81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7271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0"/>
          <p:cNvGrpSpPr/>
          <p:nvPr/>
        </p:nvGrpSpPr>
        <p:grpSpPr>
          <a:xfrm>
            <a:off x="163053" y="1014775"/>
            <a:ext cx="9084925" cy="5165571"/>
            <a:chOff x="163053" y="1014775"/>
            <a:chExt cx="9084925" cy="516557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83723" y="1014775"/>
              <a:ext cx="2700000" cy="4305498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3" t="1249" r="1078" b="2213"/>
            <a:stretch/>
          </p:blipFill>
          <p:spPr>
            <a:xfrm>
              <a:off x="5228428" y="1567257"/>
              <a:ext cx="4019550" cy="3521640"/>
            </a:xfrm>
            <a:prstGeom prst="rect">
              <a:avLst/>
            </a:prstGeom>
            <a:ln>
              <a:noFill/>
            </a:ln>
          </p:spPr>
        </p:pic>
        <p:cxnSp>
          <p:nvCxnSpPr>
            <p:cNvPr id="7" name="Straight Arrow Connector 6"/>
            <p:cNvCxnSpPr/>
            <p:nvPr/>
          </p:nvCxnSpPr>
          <p:spPr>
            <a:xfrm>
              <a:off x="4534268" y="4094943"/>
              <a:ext cx="10903" cy="160189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4052692" y="5739421"/>
              <a:ext cx="34015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p</a:t>
              </a:r>
              <a:r>
                <a:rPr lang="en-GB" sz="1400" baseline="30000" dirty="0" smtClean="0"/>
                <a:t>0</a:t>
              </a:r>
              <a:endParaRPr lang="en-GB" sz="1400" baseline="300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335573" y="5739421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WT</a:t>
              </a:r>
              <a:endParaRPr lang="en-GB" sz="1400" baseline="300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7648636" y="5677887"/>
              <a:ext cx="34015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p</a:t>
              </a:r>
              <a:r>
                <a:rPr lang="en-GB" sz="1400" baseline="30000" dirty="0" smtClean="0"/>
                <a:t>0</a:t>
              </a:r>
              <a:endParaRPr lang="en-GB" sz="1400" baseline="300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775109" y="5657126"/>
              <a:ext cx="82926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dirty="0" err="1" smtClean="0"/>
                <a:t>Cybrid</a:t>
              </a:r>
              <a:r>
                <a:rPr lang="en-GB" sz="1400" dirty="0" smtClean="0"/>
                <a:t> 10</a:t>
              </a:r>
              <a:endParaRPr lang="en-GB" sz="1400" baseline="300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73162" y="2782963"/>
              <a:ext cx="23981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(</a:t>
              </a:r>
              <a:r>
                <a:rPr lang="en-GB" sz="1400" dirty="0" err="1" smtClean="0"/>
                <a:t>nDNA</a:t>
              </a:r>
              <a:r>
                <a:rPr lang="en-GB" sz="1400" dirty="0" smtClean="0"/>
                <a:t>) ATP Synthase – 54 </a:t>
              </a:r>
              <a:r>
                <a:rPr lang="en-GB" sz="1400" dirty="0" err="1" smtClean="0"/>
                <a:t>kDa</a:t>
              </a:r>
              <a:endParaRPr lang="en-GB" sz="14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72789" y="3072841"/>
              <a:ext cx="22402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(</a:t>
              </a:r>
              <a:r>
                <a:rPr lang="en-GB" sz="1400" dirty="0" err="1" smtClean="0"/>
                <a:t>nDNA</a:t>
              </a:r>
              <a:r>
                <a:rPr lang="en-GB" sz="1400" dirty="0" smtClean="0"/>
                <a:t>) Complex III – 48 </a:t>
              </a:r>
              <a:r>
                <a:rPr lang="en-GB" sz="1400" dirty="0" err="1" smtClean="0"/>
                <a:t>kDa</a:t>
              </a:r>
              <a:endParaRPr lang="en-GB" sz="14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72789" y="3530278"/>
              <a:ext cx="219534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(</a:t>
              </a:r>
              <a:r>
                <a:rPr lang="en-GB" sz="1400" dirty="0" err="1" smtClean="0"/>
                <a:t>nDNA</a:t>
              </a:r>
              <a:r>
                <a:rPr lang="en-GB" sz="1400" dirty="0" smtClean="0"/>
                <a:t>) Complex II – 29 </a:t>
              </a:r>
              <a:r>
                <a:rPr lang="en-GB" sz="1400" dirty="0" err="1" smtClean="0"/>
                <a:t>kDa</a:t>
              </a:r>
              <a:endParaRPr lang="en-GB" sz="14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66018" y="3841182"/>
              <a:ext cx="23603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(</a:t>
              </a:r>
              <a:r>
                <a:rPr lang="en-GB" sz="1400" dirty="0" err="1" smtClean="0"/>
                <a:t>mtDNA</a:t>
              </a:r>
              <a:r>
                <a:rPr lang="en-GB" sz="1400" dirty="0" smtClean="0"/>
                <a:t>) Complex IV – 22 </a:t>
              </a:r>
              <a:r>
                <a:rPr lang="en-GB" sz="1400" dirty="0" err="1" smtClean="0"/>
                <a:t>kDa</a:t>
              </a:r>
              <a:endParaRPr lang="en-GB" sz="14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63053" y="4077038"/>
              <a:ext cx="21504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(</a:t>
              </a:r>
              <a:r>
                <a:rPr lang="en-GB" sz="1400" dirty="0" err="1" smtClean="0"/>
                <a:t>nDNA</a:t>
              </a:r>
              <a:r>
                <a:rPr lang="en-GB" sz="1400" dirty="0" smtClean="0"/>
                <a:t>) Complex I – 18 </a:t>
              </a:r>
              <a:r>
                <a:rPr lang="en-GB" sz="1400" dirty="0" err="1" smtClean="0"/>
                <a:t>kDa</a:t>
              </a:r>
              <a:endParaRPr lang="en-GB" sz="1400" dirty="0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172789" y="2795352"/>
              <a:ext cx="8547701" cy="251731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170641" y="3051274"/>
              <a:ext cx="8547701" cy="271475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181372" y="3590044"/>
              <a:ext cx="8547701" cy="251731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7" name="Rectangle 26"/>
            <p:cNvSpPr/>
            <p:nvPr/>
          </p:nvSpPr>
          <p:spPr>
            <a:xfrm>
              <a:off x="174601" y="3847933"/>
              <a:ext cx="8547701" cy="465179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35" name="Straight Arrow Connector 34"/>
            <p:cNvCxnSpPr/>
            <p:nvPr/>
          </p:nvCxnSpPr>
          <p:spPr>
            <a:xfrm>
              <a:off x="4200703" y="4094942"/>
              <a:ext cx="10903" cy="160189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Arrow Connector 35"/>
            <p:cNvCxnSpPr/>
            <p:nvPr/>
          </p:nvCxnSpPr>
          <p:spPr>
            <a:xfrm>
              <a:off x="7803205" y="4148959"/>
              <a:ext cx="10903" cy="160189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/>
            <p:cNvCxnSpPr/>
            <p:nvPr/>
          </p:nvCxnSpPr>
          <p:spPr>
            <a:xfrm>
              <a:off x="8176137" y="4123690"/>
              <a:ext cx="10903" cy="160189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5740762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45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The University of Liverpo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y Chadwick</dc:creator>
  <cp:lastModifiedBy>Amy Chadwick</cp:lastModifiedBy>
  <cp:revision>3</cp:revision>
  <dcterms:created xsi:type="dcterms:W3CDTF">2022-03-14T14:22:43Z</dcterms:created>
  <dcterms:modified xsi:type="dcterms:W3CDTF">2022-03-14T14:35:50Z</dcterms:modified>
</cp:coreProperties>
</file>